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00C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1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FB8425-1E29-4908-A18C-3069737E89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C9518BC-A602-4012-8CAD-B74F7C7862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D851A8-ED8A-4D5B-90DE-D3473013D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E2570C0-48D7-4551-AB28-57F1088BD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21A0C9-C90B-4AF2-B94C-041715D9C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3464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BA1972-2C92-45D7-8695-A05C6FEF0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87739EF-D39F-4B76-B458-7302AC1CF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8BF835-C89E-46CA-8BEF-E49C355F6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103655-300E-41D6-A690-15B25A21A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BE9DF8-BCEE-46C8-B463-2BA344BE9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744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DFCE0A2-543C-4C56-B054-A58FA6AB54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7BAF68F-2004-4ABB-BAB3-B261439D6C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70E99F-E67E-42FB-B050-D08CA24E0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12BE52-F37A-4AD1-991D-0EBCD3210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272622-A60A-4CC3-A8C1-17B5D2F33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6033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85913F-3185-4854-9B2E-73ABBCF5FF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B97ED16-9A6C-4657-94EA-911D69F0CD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A94A43-4A09-4AFE-B520-197C21EEE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BED1DD-9C9B-4424-A084-C425D336E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359133-9A1D-47C0-9B3D-98F928F52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2266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FFE5FB-574F-4F47-B832-5751ABD17C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3083C6-D947-42A2-8069-271EDA708F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91DC51-1B4E-4860-AE33-1B61CFA5C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719B26-E1D3-42DB-8AF9-E52C0224D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8B97E5-34AD-4EC8-AB41-4BCAE9E1E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149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A59EFA-C418-4564-990D-113C522C15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1437CE-A36A-424B-AF8F-8C33E74D6E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8A11477-97C2-441D-89EF-542F9BD78E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4B4934C-7607-44C9-AA14-985443698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3B841DC-9128-4507-A9DE-BA23E1434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19499A7-C0EC-440A-AB42-481807662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9352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4D450B-A4F2-47E0-9D5A-441D584FB7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C775F0-3B0A-4513-BE41-50F7D140FF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726C7B-FCC3-4C11-A618-C109DC06CC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EA5A016-4F15-46E5-91FC-A22B771ED0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68A4D5E-F8A7-4927-8123-2D3EEE87D0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1BF1271-18AA-48E5-B66F-9617FDD6C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129F735-1764-45EC-BF8B-FD9202689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0C4E576-C126-4EF0-BB46-EBD2988CB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3210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E05B5E-2BB0-4BDC-8184-193177284A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01477C7-ACDF-4B5E-8CC0-E3F7D4034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6EE602C-9CD4-4540-A250-922DACBE3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DDEC57D-CC45-43C2-BAF9-421E3546E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4683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AD68E76-F86F-44C0-9C37-6B8AD80BC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82F7D4F-6750-45F6-ADC5-B13DFFAB5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226BC40-38AE-4C9F-9A4B-680D65A0D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255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76B0D1-B211-472E-86F9-6FEFFCFE3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A347903-0BAF-4098-B7B2-71767FEE77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6EA1A8E-0137-4EC3-8436-1C6E9DD3AE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0B8936-8274-4008-ABB0-59CABFB93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C6DC484-4B1D-4354-AA09-F1505E666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3889771-6C59-4EFB-86B4-BDCFA73B1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8021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2F9C4B-8316-4E40-B8B7-1E4400D2BE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A80BB0E-E9F3-44C8-AE61-DED4E8DC73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5D94B8-4B08-44BA-8A08-1841D25B45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E5C839C-E310-45DA-A1DD-331EBD0CB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31F9F62-DD5A-4DAF-838D-978B0C7EC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1600EE-C7EE-46AF-A829-7D87D79ED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2714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E25CA6B-0499-4893-B436-089635ED67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E8A902-7717-44B4-9DB6-CA6F107F62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AF60F2B-9FA5-4646-B26C-1E46095136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CF6C1-F6E7-4846-AF67-DD5876D537D6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6643C8-13C5-41F2-8AA6-8489109020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7F3475-7849-4A41-BBFB-5ADFC67C64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CB1109-176A-4EAA-89F9-1D2848C4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4415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12" Type="http://schemas.openxmlformats.org/officeDocument/2006/relationships/image" Target="../media/image21.png"/><Relationship Id="rId2" Type="http://schemas.openxmlformats.org/officeDocument/2006/relationships/image" Target="../media/image11.png"/><Relationship Id="rId16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5" Type="http://schemas.openxmlformats.org/officeDocument/2006/relationships/image" Target="../media/image2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00E5987-6694-4B11-B4A6-130D876A5ED6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3262" y="2565048"/>
            <a:ext cx="2255999" cy="1692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EC4063E-EB45-4F71-B9A8-7A21E7FC0E21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56983" y="2565048"/>
            <a:ext cx="2256000" cy="1692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217B162-ED43-44E0-9B62-2F90B425E778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80705" y="2565048"/>
            <a:ext cx="2256000" cy="1692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63425690-FE18-437F-8E45-D0B35EDB886B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04427" y="2565048"/>
            <a:ext cx="2256000" cy="1692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DD66231C-187F-4EAF-A5EB-E8122BFABB54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728150" y="2565048"/>
            <a:ext cx="2256000" cy="1692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71615C17-FD60-4668-B1FB-0FB4C11D978D}"/>
              </a:ext>
            </a:extLst>
          </p:cNvPr>
          <p:cNvSpPr txBox="1"/>
          <p:nvPr/>
        </p:nvSpPr>
        <p:spPr>
          <a:xfrm rot="16200000">
            <a:off x="-1066295" y="3226382"/>
            <a:ext cx="26296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H&amp;E Staining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93F738D-0C56-4BF7-A920-8E22D5724F80}"/>
              </a:ext>
            </a:extLst>
          </p:cNvPr>
          <p:cNvSpPr txBox="1"/>
          <p:nvPr/>
        </p:nvSpPr>
        <p:spPr>
          <a:xfrm>
            <a:off x="1305997" y="2198144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14C5B9D-3BFB-4545-B021-C63989F1B8E7}"/>
              </a:ext>
            </a:extLst>
          </p:cNvPr>
          <p:cNvSpPr txBox="1"/>
          <p:nvPr/>
        </p:nvSpPr>
        <p:spPr>
          <a:xfrm>
            <a:off x="3572672" y="2198144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Cl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052585D-4EC6-4184-B35D-8A2D8FE0DD1E}"/>
              </a:ext>
            </a:extLst>
          </p:cNvPr>
          <p:cNvSpPr txBox="1"/>
          <p:nvPr/>
        </p:nvSpPr>
        <p:spPr>
          <a:xfrm>
            <a:off x="6029731" y="2198144"/>
            <a:ext cx="441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433AF5D-AF60-4FB3-A127-C15F6B47B4B9}"/>
              </a:ext>
            </a:extLst>
          </p:cNvPr>
          <p:cNvSpPr txBox="1"/>
          <p:nvPr/>
        </p:nvSpPr>
        <p:spPr>
          <a:xfrm>
            <a:off x="8359535" y="2198144"/>
            <a:ext cx="441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BF279E6-1CA8-41E5-864D-DC5EF477F63B}"/>
              </a:ext>
            </a:extLst>
          </p:cNvPr>
          <p:cNvSpPr txBox="1"/>
          <p:nvPr/>
        </p:nvSpPr>
        <p:spPr>
          <a:xfrm>
            <a:off x="10573926" y="2198144"/>
            <a:ext cx="569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2BB4B7C7-1E94-4DE7-ADF9-82B3ABAD78FB}"/>
              </a:ext>
            </a:extLst>
          </p:cNvPr>
          <p:cNvCxnSpPr>
            <a:stCxn id="15" idx="0"/>
            <a:endCxn id="17" idx="0"/>
          </p:cNvCxnSpPr>
          <p:nvPr/>
        </p:nvCxnSpPr>
        <p:spPr>
          <a:xfrm>
            <a:off x="6250305" y="2198144"/>
            <a:ext cx="46083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33E34D71-2DDE-4CB2-B0EB-BEFEF0637DF3}"/>
              </a:ext>
            </a:extLst>
          </p:cNvPr>
          <p:cNvSpPr txBox="1"/>
          <p:nvPr/>
        </p:nvSpPr>
        <p:spPr>
          <a:xfrm>
            <a:off x="7340434" y="1827599"/>
            <a:ext cx="2383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Cl4+AHWE(mg/kg)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AFD606E-2EC1-4D34-ADBF-A41F46C391DA}"/>
              </a:ext>
            </a:extLst>
          </p:cNvPr>
          <p:cNvSpPr txBox="1"/>
          <p:nvPr/>
        </p:nvSpPr>
        <p:spPr>
          <a:xfrm>
            <a:off x="-11757" y="-9400"/>
            <a:ext cx="13308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E</a:t>
            </a:r>
          </a:p>
        </p:txBody>
      </p:sp>
    </p:spTree>
    <p:extLst>
      <p:ext uri="{BB962C8B-B14F-4D97-AF65-F5344CB8AC3E}">
        <p14:creationId xmlns:p14="http://schemas.microsoft.com/office/powerpoint/2010/main" val="186618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D5302D7-C530-4A40-9AE8-E4521BC9EFE7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9454" y="2598525"/>
            <a:ext cx="2256000" cy="1692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AA288D2-28CC-4833-BB14-9318B157541E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53196" y="2598525"/>
            <a:ext cx="2256000" cy="1692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B3BF012-DF72-4E7A-BDCE-AE6BFE772B46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76938" y="2598525"/>
            <a:ext cx="2256000" cy="1692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E2E97B7-F0B6-490A-9D78-0B2559788463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00680" y="2598525"/>
            <a:ext cx="2256000" cy="1692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A91581F-4E6D-4B02-BEDD-6F506B3165B2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724421" y="2598525"/>
            <a:ext cx="2256000" cy="1692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DCC9045-1293-4BFE-A9EC-5472B0ED146C}"/>
              </a:ext>
            </a:extLst>
          </p:cNvPr>
          <p:cNvSpPr txBox="1"/>
          <p:nvPr/>
        </p:nvSpPr>
        <p:spPr>
          <a:xfrm>
            <a:off x="-11757" y="-9400"/>
            <a:ext cx="13516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A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5CC762E-C744-4474-9151-81FDE032C311}"/>
              </a:ext>
            </a:extLst>
          </p:cNvPr>
          <p:cNvSpPr txBox="1"/>
          <p:nvPr/>
        </p:nvSpPr>
        <p:spPr>
          <a:xfrm>
            <a:off x="1305997" y="2198144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0FF2743-E7D8-44EF-B4C9-3B90BE07DF83}"/>
              </a:ext>
            </a:extLst>
          </p:cNvPr>
          <p:cNvSpPr txBox="1"/>
          <p:nvPr/>
        </p:nvSpPr>
        <p:spPr>
          <a:xfrm>
            <a:off x="3572672" y="2198144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Cl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D152B92-0FF4-47A2-9FFE-3C614DD40CFC}"/>
              </a:ext>
            </a:extLst>
          </p:cNvPr>
          <p:cNvSpPr txBox="1"/>
          <p:nvPr/>
        </p:nvSpPr>
        <p:spPr>
          <a:xfrm>
            <a:off x="6029731" y="2198144"/>
            <a:ext cx="441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A81C2B7-513B-4BB4-8340-3312CC8286E8}"/>
              </a:ext>
            </a:extLst>
          </p:cNvPr>
          <p:cNvSpPr txBox="1"/>
          <p:nvPr/>
        </p:nvSpPr>
        <p:spPr>
          <a:xfrm>
            <a:off x="8359535" y="2198144"/>
            <a:ext cx="441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6DF9616-F6A9-4272-A543-3CB92DCFF322}"/>
              </a:ext>
            </a:extLst>
          </p:cNvPr>
          <p:cNvSpPr txBox="1"/>
          <p:nvPr/>
        </p:nvSpPr>
        <p:spPr>
          <a:xfrm>
            <a:off x="10573926" y="2198144"/>
            <a:ext cx="569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C1877A6A-B0D5-4E17-9E83-064648CB77CD}"/>
              </a:ext>
            </a:extLst>
          </p:cNvPr>
          <p:cNvCxnSpPr>
            <a:stCxn id="20" idx="0"/>
            <a:endCxn id="22" idx="0"/>
          </p:cNvCxnSpPr>
          <p:nvPr/>
        </p:nvCxnSpPr>
        <p:spPr>
          <a:xfrm>
            <a:off x="6250305" y="2198144"/>
            <a:ext cx="46083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49BC6914-8AB7-43BE-BFA3-EAB22E46DBDA}"/>
              </a:ext>
            </a:extLst>
          </p:cNvPr>
          <p:cNvSpPr txBox="1"/>
          <p:nvPr/>
        </p:nvSpPr>
        <p:spPr>
          <a:xfrm>
            <a:off x="7340434" y="1827599"/>
            <a:ext cx="2383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Cl4+AHWE(mg/kg)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35051F9-597D-4660-B74C-1BBFCADBFADD}"/>
              </a:ext>
            </a:extLst>
          </p:cNvPr>
          <p:cNvSpPr txBox="1"/>
          <p:nvPr/>
        </p:nvSpPr>
        <p:spPr>
          <a:xfrm rot="16200000">
            <a:off x="-1066295" y="3226382"/>
            <a:ext cx="26296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asson Staining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12805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F5927D93-9B7B-4042-A312-F63BDA47A094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14145" y="2784136"/>
            <a:ext cx="1994080" cy="1980000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A00B5338-3C0E-43B4-BCA4-4682AC3C0287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14145" y="741301"/>
            <a:ext cx="1994081" cy="1980000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024B363C-A288-41BA-BE7B-AA2DB72B2554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44633" y="741301"/>
            <a:ext cx="1997600" cy="19800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BB7F9FC-2D24-446C-9F44-4217961B8D0B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78640" y="741301"/>
            <a:ext cx="1997600" cy="19800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33D742A6-F346-467C-8CC6-BBDF70FB2448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12647" y="741301"/>
            <a:ext cx="1997600" cy="198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9C331BB-AC30-4E6B-B21B-7DBE11D9111F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46656" y="741301"/>
            <a:ext cx="1999360" cy="1980000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0CDB414F-9EB5-471F-B3BD-39283764710B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45074" y="2788632"/>
            <a:ext cx="1995840" cy="1980000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C9407100-3D7F-4058-B5C5-31F06C07DF71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77762" y="2788632"/>
            <a:ext cx="1997600" cy="1980000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2E25880D-6C72-4AF4-8FE9-1BE741649B41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12209" y="2788632"/>
            <a:ext cx="1997600" cy="1980000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FAD0E6E1-3352-44C2-AA17-711880D997F4}"/>
              </a:ext>
            </a:extLst>
          </p:cNvPr>
          <p:cNvPicPr>
            <a:picLocks noChangeAspect="1"/>
          </p:cNvPicPr>
          <p:nvPr/>
        </p:nvPicPr>
        <p:blipFill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46656" y="2788632"/>
            <a:ext cx="1997600" cy="1980000"/>
          </a:xfrm>
          <a:prstGeom prst="rect">
            <a:avLst/>
          </a:prstGeom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A991BB42-1931-4EE0-A64C-918B26553C49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14145" y="4835963"/>
            <a:ext cx="1994080" cy="1980000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F7A52071-3413-409B-88F2-844DF9A5E9C8}"/>
              </a:ext>
            </a:extLst>
          </p:cNvPr>
          <p:cNvPicPr>
            <a:picLocks noChangeAspect="1"/>
          </p:cNvPicPr>
          <p:nvPr/>
        </p:nvPicPr>
        <p:blipFill>
          <a:blip r:embed="rId1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45073" y="4835963"/>
            <a:ext cx="1995840" cy="1980000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6A938E10-FB02-4563-8D02-DDADF37E4552}"/>
              </a:ext>
            </a:extLst>
          </p:cNvPr>
          <p:cNvPicPr>
            <a:picLocks noChangeAspect="1"/>
          </p:cNvPicPr>
          <p:nvPr/>
        </p:nvPicPr>
        <p:blipFill>
          <a:blip r:embed="rId1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77761" y="4835963"/>
            <a:ext cx="1997600" cy="1980000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B2890A7B-7478-42F3-AADF-721C1EBC007C}"/>
              </a:ext>
            </a:extLst>
          </p:cNvPr>
          <p:cNvPicPr>
            <a:picLocks noChangeAspect="1"/>
          </p:cNvPicPr>
          <p:nvPr/>
        </p:nvPicPr>
        <p:blipFill>
          <a:blip r:embed="rId1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12209" y="4835963"/>
            <a:ext cx="1997600" cy="1980000"/>
          </a:xfrm>
          <a:prstGeom prst="rect">
            <a:avLst/>
          </a:prstGeom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5DA5A8BD-7B56-4514-BBEE-F5FDFAB8EDB0}"/>
              </a:ext>
            </a:extLst>
          </p:cNvPr>
          <p:cNvPicPr>
            <a:picLocks noChangeAspect="1"/>
          </p:cNvPicPr>
          <p:nvPr/>
        </p:nvPicPr>
        <p:blipFill>
          <a:blip r:embed="rId1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46656" y="4835963"/>
            <a:ext cx="1997600" cy="1980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CF2291C-83C2-458A-92EF-B212ED7E4B42}"/>
              </a:ext>
            </a:extLst>
          </p:cNvPr>
          <p:cNvSpPr txBox="1"/>
          <p:nvPr/>
        </p:nvSpPr>
        <p:spPr>
          <a:xfrm rot="16200000">
            <a:off x="475488" y="1620012"/>
            <a:ext cx="881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0FD64888-F51A-439D-A949-5567D0A528E1}"/>
              </a:ext>
            </a:extLst>
          </p:cNvPr>
          <p:cNvSpPr txBox="1"/>
          <p:nvPr/>
        </p:nvSpPr>
        <p:spPr>
          <a:xfrm rot="16200000">
            <a:off x="548136" y="3593966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E8BACDB5-BA57-49BB-B0D2-17B1057FE3F8}"/>
              </a:ext>
            </a:extLst>
          </p:cNvPr>
          <p:cNvSpPr txBox="1"/>
          <p:nvPr/>
        </p:nvSpPr>
        <p:spPr>
          <a:xfrm rot="16200000">
            <a:off x="484016" y="564129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100C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b="1" dirty="0">
              <a:solidFill>
                <a:srgbClr val="F100C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9DBBDB7A-9608-49CA-A5D7-709467207BA1}"/>
              </a:ext>
            </a:extLst>
          </p:cNvPr>
          <p:cNvSpPr txBox="1"/>
          <p:nvPr/>
        </p:nvSpPr>
        <p:spPr>
          <a:xfrm>
            <a:off x="1952882" y="390733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975CC25B-8545-4E5D-A6CC-591E6300D09E}"/>
              </a:ext>
            </a:extLst>
          </p:cNvPr>
          <p:cNvSpPr txBox="1"/>
          <p:nvPr/>
        </p:nvSpPr>
        <p:spPr>
          <a:xfrm>
            <a:off x="3746703" y="390733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0E3A43A2-3402-4D56-ADAD-F1C17B5F3EE2}"/>
              </a:ext>
            </a:extLst>
          </p:cNvPr>
          <p:cNvSpPr txBox="1"/>
          <p:nvPr/>
        </p:nvSpPr>
        <p:spPr>
          <a:xfrm>
            <a:off x="5985455" y="390733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4EC9CFC1-3987-4456-ADA1-99EAAEC081DF}"/>
              </a:ext>
            </a:extLst>
          </p:cNvPr>
          <p:cNvSpPr txBox="1"/>
          <p:nvPr/>
        </p:nvSpPr>
        <p:spPr>
          <a:xfrm>
            <a:off x="8027481" y="39073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E34181F8-D3BF-4EFF-BD1A-4CECBC93BA2A}"/>
              </a:ext>
            </a:extLst>
          </p:cNvPr>
          <p:cNvSpPr txBox="1"/>
          <p:nvPr/>
        </p:nvSpPr>
        <p:spPr>
          <a:xfrm>
            <a:off x="10092822" y="39073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6C569495-31E0-49AE-9E27-A38E038CD3CC}"/>
              </a:ext>
            </a:extLst>
          </p:cNvPr>
          <p:cNvCxnSpPr>
            <a:stCxn id="79" idx="0"/>
            <a:endCxn id="81" idx="0"/>
          </p:cNvCxnSpPr>
          <p:nvPr/>
        </p:nvCxnSpPr>
        <p:spPr>
          <a:xfrm>
            <a:off x="6302209" y="390733"/>
            <a:ext cx="404324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B94ADCBD-E2E5-4586-9AFA-4B149AF1B551}"/>
              </a:ext>
            </a:extLst>
          </p:cNvPr>
          <p:cNvSpPr txBox="1"/>
          <p:nvPr/>
        </p:nvSpPr>
        <p:spPr>
          <a:xfrm>
            <a:off x="7363837" y="12020"/>
            <a:ext cx="1832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TGF-β1+AHW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2FC9979E-D0E1-47FC-AE67-9E007F591359}"/>
              </a:ext>
            </a:extLst>
          </p:cNvPr>
          <p:cNvSpPr/>
          <p:nvPr/>
        </p:nvSpPr>
        <p:spPr>
          <a:xfrm>
            <a:off x="1325880" y="1711452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E5EE4315-A9BC-432F-AB25-81B3431633FA}"/>
              </a:ext>
            </a:extLst>
          </p:cNvPr>
          <p:cNvSpPr/>
          <p:nvPr/>
        </p:nvSpPr>
        <p:spPr>
          <a:xfrm>
            <a:off x="3386703" y="914283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EB49D19C-449B-4541-9ACC-EA819A386B85}"/>
              </a:ext>
            </a:extLst>
          </p:cNvPr>
          <p:cNvSpPr/>
          <p:nvPr/>
        </p:nvSpPr>
        <p:spPr>
          <a:xfrm>
            <a:off x="6428003" y="794566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92A1A700-3262-4A8E-A3F1-A321D8727D7F}"/>
              </a:ext>
            </a:extLst>
          </p:cNvPr>
          <p:cNvSpPr/>
          <p:nvPr/>
        </p:nvSpPr>
        <p:spPr>
          <a:xfrm>
            <a:off x="8172748" y="1425899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1B8C1995-1F4C-46BE-90C4-B6C9401F7E78}"/>
              </a:ext>
            </a:extLst>
          </p:cNvPr>
          <p:cNvSpPr/>
          <p:nvPr/>
        </p:nvSpPr>
        <p:spPr>
          <a:xfrm>
            <a:off x="10339841" y="1229067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5385ED6B-C64D-4E54-B128-F725579BDCCF}"/>
              </a:ext>
            </a:extLst>
          </p:cNvPr>
          <p:cNvSpPr/>
          <p:nvPr/>
        </p:nvSpPr>
        <p:spPr>
          <a:xfrm>
            <a:off x="1325880" y="3742394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F58FAE3B-CFDC-471D-B8A7-9F9CE2984423}"/>
              </a:ext>
            </a:extLst>
          </p:cNvPr>
          <p:cNvSpPr/>
          <p:nvPr/>
        </p:nvSpPr>
        <p:spPr>
          <a:xfrm>
            <a:off x="1325880" y="5773407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矩形 93">
            <a:extLst>
              <a:ext uri="{FF2B5EF4-FFF2-40B4-BE49-F238E27FC236}">
                <a16:creationId xmlns:a16="http://schemas.microsoft.com/office/drawing/2014/main" id="{9143E137-244A-4008-A9D7-2D45AFBF8D16}"/>
              </a:ext>
            </a:extLst>
          </p:cNvPr>
          <p:cNvSpPr/>
          <p:nvPr/>
        </p:nvSpPr>
        <p:spPr>
          <a:xfrm>
            <a:off x="3386703" y="2959659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2ACB4F0F-F12A-491D-AC86-4B7B8991039A}"/>
              </a:ext>
            </a:extLst>
          </p:cNvPr>
          <p:cNvSpPr/>
          <p:nvPr/>
        </p:nvSpPr>
        <p:spPr>
          <a:xfrm>
            <a:off x="3386703" y="5002595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矩形 95">
            <a:extLst>
              <a:ext uri="{FF2B5EF4-FFF2-40B4-BE49-F238E27FC236}">
                <a16:creationId xmlns:a16="http://schemas.microsoft.com/office/drawing/2014/main" id="{A62B65AE-A065-4FF3-820B-8F9EB9230700}"/>
              </a:ext>
            </a:extLst>
          </p:cNvPr>
          <p:cNvSpPr/>
          <p:nvPr/>
        </p:nvSpPr>
        <p:spPr>
          <a:xfrm>
            <a:off x="6428003" y="2844583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7BD88132-8B27-4AF8-B402-CEFE8BB3A543}"/>
              </a:ext>
            </a:extLst>
          </p:cNvPr>
          <p:cNvSpPr/>
          <p:nvPr/>
        </p:nvSpPr>
        <p:spPr>
          <a:xfrm>
            <a:off x="6428003" y="4896121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矩形 97">
            <a:extLst>
              <a:ext uri="{FF2B5EF4-FFF2-40B4-BE49-F238E27FC236}">
                <a16:creationId xmlns:a16="http://schemas.microsoft.com/office/drawing/2014/main" id="{BF33F4ED-B68B-4EE7-9925-DA6A82313D03}"/>
              </a:ext>
            </a:extLst>
          </p:cNvPr>
          <p:cNvSpPr/>
          <p:nvPr/>
        </p:nvSpPr>
        <p:spPr>
          <a:xfrm>
            <a:off x="8172748" y="3426887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9" name="矩形 98">
            <a:extLst>
              <a:ext uri="{FF2B5EF4-FFF2-40B4-BE49-F238E27FC236}">
                <a16:creationId xmlns:a16="http://schemas.microsoft.com/office/drawing/2014/main" id="{C0B287F1-2AFF-4F94-8EBB-57C12DAC8F6A}"/>
              </a:ext>
            </a:extLst>
          </p:cNvPr>
          <p:cNvSpPr/>
          <p:nvPr/>
        </p:nvSpPr>
        <p:spPr>
          <a:xfrm>
            <a:off x="8172748" y="5548181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DFB018CC-5063-4C14-8988-A927416BBE41}"/>
              </a:ext>
            </a:extLst>
          </p:cNvPr>
          <p:cNvSpPr/>
          <p:nvPr/>
        </p:nvSpPr>
        <p:spPr>
          <a:xfrm>
            <a:off x="10339841" y="3261977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6087C39B-2A73-4326-931A-511B500B8ECF}"/>
              </a:ext>
            </a:extLst>
          </p:cNvPr>
          <p:cNvSpPr/>
          <p:nvPr/>
        </p:nvSpPr>
        <p:spPr>
          <a:xfrm>
            <a:off x="10338187" y="5304941"/>
            <a:ext cx="720000" cy="72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01DF1F4C-CE6A-4E03-8C12-C224A9EED577}"/>
              </a:ext>
            </a:extLst>
          </p:cNvPr>
          <p:cNvSpPr txBox="1"/>
          <p:nvPr/>
        </p:nvSpPr>
        <p:spPr>
          <a:xfrm>
            <a:off x="-11757" y="-9400"/>
            <a:ext cx="13516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C</a:t>
            </a:r>
          </a:p>
        </p:txBody>
      </p:sp>
    </p:spTree>
    <p:extLst>
      <p:ext uri="{BB962C8B-B14F-4D97-AF65-F5344CB8AC3E}">
        <p14:creationId xmlns:p14="http://schemas.microsoft.com/office/powerpoint/2010/main" val="16985642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D68C569B-C431-445C-B714-4EBADB212F43}"/>
              </a:ext>
            </a:extLst>
          </p:cNvPr>
          <p:cNvSpPr txBox="1"/>
          <p:nvPr/>
        </p:nvSpPr>
        <p:spPr>
          <a:xfrm>
            <a:off x="-11757" y="-9400"/>
            <a:ext cx="13516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7A</a:t>
            </a:r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11515EA6-7C9C-4649-A93E-D147522E832E}"/>
              </a:ext>
            </a:extLst>
          </p:cNvPr>
          <p:cNvPicPr>
            <a:picLocks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723221" y="2612853"/>
            <a:ext cx="2257200" cy="1606820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71DB1E21-05D6-40F8-AA1D-6B8E286BC3C0}"/>
              </a:ext>
            </a:extLst>
          </p:cNvPr>
          <p:cNvPicPr>
            <a:picLocks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99780" y="2612853"/>
            <a:ext cx="2257200" cy="1606820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D71AE341-35D9-4047-BE1A-6A43548380A7}"/>
              </a:ext>
            </a:extLst>
          </p:cNvPr>
          <p:cNvPicPr>
            <a:picLocks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76338" y="2612853"/>
            <a:ext cx="2257200" cy="1604102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79F29852-4DB4-4CDA-987D-99DE60827803}"/>
              </a:ext>
            </a:extLst>
          </p:cNvPr>
          <p:cNvPicPr>
            <a:picLocks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52896" y="2612853"/>
            <a:ext cx="2257200" cy="1606820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E5C308ED-45FF-46BE-B56F-73D81D7F2DDA}"/>
              </a:ext>
            </a:extLst>
          </p:cNvPr>
          <p:cNvPicPr>
            <a:picLocks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9454" y="2612853"/>
            <a:ext cx="2257200" cy="1606820"/>
          </a:xfrm>
          <a:prstGeom prst="rect">
            <a:avLst/>
          </a:prstGeom>
        </p:spPr>
      </p:pic>
      <p:sp>
        <p:nvSpPr>
          <p:cNvPr id="81" name="文本框 80">
            <a:extLst>
              <a:ext uri="{FF2B5EF4-FFF2-40B4-BE49-F238E27FC236}">
                <a16:creationId xmlns:a16="http://schemas.microsoft.com/office/drawing/2014/main" id="{75B320E5-9A9D-4C01-8468-943BB7054818}"/>
              </a:ext>
            </a:extLst>
          </p:cNvPr>
          <p:cNvSpPr txBox="1"/>
          <p:nvPr/>
        </p:nvSpPr>
        <p:spPr>
          <a:xfrm>
            <a:off x="1305997" y="2198144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C274DC6A-C3B4-4548-993D-F9473D6C9AF1}"/>
              </a:ext>
            </a:extLst>
          </p:cNvPr>
          <p:cNvSpPr txBox="1"/>
          <p:nvPr/>
        </p:nvSpPr>
        <p:spPr>
          <a:xfrm>
            <a:off x="3572672" y="2198144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Cl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A40229FB-5E58-4C85-9BE3-8A5534C125A9}"/>
              </a:ext>
            </a:extLst>
          </p:cNvPr>
          <p:cNvSpPr txBox="1"/>
          <p:nvPr/>
        </p:nvSpPr>
        <p:spPr>
          <a:xfrm>
            <a:off x="6029731" y="2198144"/>
            <a:ext cx="441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775FFA01-08BA-4C11-8D6B-033142D0BC97}"/>
              </a:ext>
            </a:extLst>
          </p:cNvPr>
          <p:cNvSpPr txBox="1"/>
          <p:nvPr/>
        </p:nvSpPr>
        <p:spPr>
          <a:xfrm>
            <a:off x="8359535" y="2198144"/>
            <a:ext cx="441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392846D1-DBFB-4FE1-BCCA-0A4CFC6CF3A2}"/>
              </a:ext>
            </a:extLst>
          </p:cNvPr>
          <p:cNvSpPr txBox="1"/>
          <p:nvPr/>
        </p:nvSpPr>
        <p:spPr>
          <a:xfrm>
            <a:off x="10573926" y="2198144"/>
            <a:ext cx="569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67556A57-1C0F-43EF-AF6E-1B5061F80874}"/>
              </a:ext>
            </a:extLst>
          </p:cNvPr>
          <p:cNvCxnSpPr>
            <a:stCxn id="83" idx="0"/>
            <a:endCxn id="85" idx="0"/>
          </p:cNvCxnSpPr>
          <p:nvPr/>
        </p:nvCxnSpPr>
        <p:spPr>
          <a:xfrm>
            <a:off x="6250305" y="2198144"/>
            <a:ext cx="460831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475A8A0C-D73D-4300-AA5A-295F0EB0D2F1}"/>
              </a:ext>
            </a:extLst>
          </p:cNvPr>
          <p:cNvSpPr txBox="1"/>
          <p:nvPr/>
        </p:nvSpPr>
        <p:spPr>
          <a:xfrm>
            <a:off x="7340434" y="1827599"/>
            <a:ext cx="2383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Cl4+AHWE(mg/kg)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D2A8D041-25A2-4E88-9302-3ADC54DA21F5}"/>
              </a:ext>
            </a:extLst>
          </p:cNvPr>
          <p:cNvSpPr txBox="1"/>
          <p:nvPr/>
        </p:nvSpPr>
        <p:spPr>
          <a:xfrm rot="16200000">
            <a:off x="-1066295" y="3226382"/>
            <a:ext cx="26296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2788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69</Words>
  <Application>Microsoft Office PowerPoint</Application>
  <PresentationFormat>宽屏</PresentationFormat>
  <Paragraphs>3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安琳</dc:creator>
  <cp:lastModifiedBy>安琳</cp:lastModifiedBy>
  <cp:revision>12</cp:revision>
  <dcterms:created xsi:type="dcterms:W3CDTF">2022-09-15T01:37:55Z</dcterms:created>
  <dcterms:modified xsi:type="dcterms:W3CDTF">2022-09-15T02:59:25Z</dcterms:modified>
</cp:coreProperties>
</file>